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72" y="2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CM\Priv\Projet%20cyclases\articles%20en%20cours\article%20signal\Raw%20data\data_Fig%20paper%20Signal%201%20AOI\Fig%203\Fig%20S3_C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CM\Priv\Projet%20cyclases\articles%20en%20cours\article%20signal\Raw%20data\data_Fig%20paper%20Signal%201%20AOI\Fig%203\Fig%20S3_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CM\Priv\Projet%20cyclases\articles%20en%20cours\article%20signal\Raw%20data\data_Fig%20paper%20Signal%201%20AOI\Fig%203\Fig%20S3_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785194929861338"/>
          <c:y val="4.3573047558453946E-2"/>
          <c:w val="0.74214805070138801"/>
          <c:h val="0.8497276125338029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raw_data Fig S3-c'!$D$4:$D$5</c:f>
              <c:strCache>
                <c:ptCount val="2"/>
                <c:pt idx="0">
                  <c:v>L2-Streptag</c:v>
                </c:pt>
                <c:pt idx="1">
                  <c:v>SMc02178-Streptag</c:v>
                </c:pt>
              </c:strCache>
            </c:strRef>
          </c:cat>
          <c:val>
            <c:numRef>
              <c:f>'raw_data Fig S3-c'!$G$4:$G$5</c:f>
              <c:numCache>
                <c:formatCode>General</c:formatCode>
                <c:ptCount val="2"/>
                <c:pt idx="0">
                  <c:v>1897.7272727272759</c:v>
                </c:pt>
                <c:pt idx="1">
                  <c:v>184.427272727272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0E-4736-AEE3-4B5D32BD4C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52027392"/>
        <c:axId val="52028928"/>
      </c:barChart>
      <c:catAx>
        <c:axId val="520273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52028928"/>
        <c:crosses val="autoZero"/>
        <c:auto val="1"/>
        <c:lblAlgn val="ctr"/>
        <c:lblOffset val="100"/>
        <c:noMultiLvlLbl val="0"/>
      </c:catAx>
      <c:valAx>
        <c:axId val="520289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2027392"/>
        <c:crosses val="autoZero"/>
        <c:crossBetween val="between"/>
        <c:majorUnit val="400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78E8-4A5C-9AE6-6F802A7DF3C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8E8-4A5C-9AE6-6F802A7DF3CA}"/>
              </c:ext>
            </c:extLst>
          </c:dPt>
          <c:errBars>
            <c:errBarType val="both"/>
            <c:errValType val="cust"/>
            <c:noEndCap val="0"/>
            <c:plus>
              <c:numRef>
                <c:f>'raw_data Fig S3-a'!$P$4:$P$5</c:f>
                <c:numCache>
                  <c:formatCode>General</c:formatCode>
                  <c:ptCount val="2"/>
                  <c:pt idx="0">
                    <c:v>29.657342639072759</c:v>
                  </c:pt>
                  <c:pt idx="1">
                    <c:v>7.8213385261919663</c:v>
                  </c:pt>
                </c:numCache>
              </c:numRef>
            </c:plus>
            <c:minus>
              <c:numRef>
                <c:f>'raw_data Fig S3-a'!$P$4:$P$5</c:f>
                <c:numCache>
                  <c:formatCode>General</c:formatCode>
                  <c:ptCount val="2"/>
                  <c:pt idx="0">
                    <c:v>29.657342639072759</c:v>
                  </c:pt>
                  <c:pt idx="1">
                    <c:v>7.82133852619196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w_data Fig S3-a'!$K$4:$K$5</c:f>
              <c:strCache>
                <c:ptCount val="2"/>
                <c:pt idx="0">
                  <c:v>Buffer </c:v>
                </c:pt>
                <c:pt idx="1">
                  <c:v>Peptide Strep-tag</c:v>
                </c:pt>
              </c:strCache>
            </c:strRef>
          </c:cat>
          <c:val>
            <c:numRef>
              <c:f>'raw_data Fig S3-a'!$O$4:$O$5</c:f>
              <c:numCache>
                <c:formatCode>General</c:formatCode>
                <c:ptCount val="2"/>
                <c:pt idx="0">
                  <c:v>234.80220158238777</c:v>
                </c:pt>
                <c:pt idx="1">
                  <c:v>224.61741474899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10-47CB-8915-513F2278F7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7"/>
        <c:axId val="55637888"/>
        <c:axId val="55639424"/>
      </c:barChart>
      <c:catAx>
        <c:axId val="556378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55639424"/>
        <c:crosses val="autoZero"/>
        <c:auto val="1"/>
        <c:lblAlgn val="ctr"/>
        <c:lblOffset val="100"/>
        <c:noMultiLvlLbl val="0"/>
      </c:catAx>
      <c:valAx>
        <c:axId val="556394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5637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095957431748671"/>
          <c:y val="3.2065749116709626E-2"/>
          <c:w val="0.77978696744251874"/>
          <c:h val="0.8727627836894763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'raw_data Fig S3-b'!$B$5:$B$14</c:f>
              <c:strCache>
                <c:ptCount val="10"/>
                <c:pt idx="0">
                  <c:v>Control buffer</c:v>
                </c:pt>
                <c:pt idx="1">
                  <c:v>Crude extract</c:v>
                </c:pt>
                <c:pt idx="2">
                  <c:v>Flowthrough</c:v>
                </c:pt>
                <c:pt idx="3">
                  <c:v>Last wash step</c:v>
                </c:pt>
                <c:pt idx="4">
                  <c:v>E1</c:v>
                </c:pt>
                <c:pt idx="5">
                  <c:v>E2</c:v>
                </c:pt>
                <c:pt idx="6">
                  <c:v>E3</c:v>
                </c:pt>
                <c:pt idx="7">
                  <c:v>E4</c:v>
                </c:pt>
                <c:pt idx="8">
                  <c:v>E5</c:v>
                </c:pt>
                <c:pt idx="9">
                  <c:v>E6</c:v>
                </c:pt>
              </c:strCache>
            </c:strRef>
          </c:cat>
          <c:val>
            <c:numRef>
              <c:f>'raw_data Fig S3-b'!$C$5:$C$14</c:f>
              <c:numCache>
                <c:formatCode>General</c:formatCode>
                <c:ptCount val="10"/>
                <c:pt idx="0">
                  <c:v>187.9</c:v>
                </c:pt>
                <c:pt idx="1">
                  <c:v>2758.8</c:v>
                </c:pt>
                <c:pt idx="2">
                  <c:v>2636.9</c:v>
                </c:pt>
                <c:pt idx="3">
                  <c:v>268.3</c:v>
                </c:pt>
                <c:pt idx="4">
                  <c:v>209.7</c:v>
                </c:pt>
                <c:pt idx="5">
                  <c:v>163.9</c:v>
                </c:pt>
                <c:pt idx="6">
                  <c:v>167.4</c:v>
                </c:pt>
                <c:pt idx="7">
                  <c:v>161.9</c:v>
                </c:pt>
                <c:pt idx="8">
                  <c:v>172.1</c:v>
                </c:pt>
                <c:pt idx="9">
                  <c:v>16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82-4789-A541-82E94AA3ED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9"/>
        <c:overlap val="-27"/>
        <c:axId val="55615488"/>
        <c:axId val="55617024"/>
      </c:barChart>
      <c:catAx>
        <c:axId val="556154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55617024"/>
        <c:crosses val="autoZero"/>
        <c:auto val="1"/>
        <c:lblAlgn val="ctr"/>
        <c:lblOffset val="100"/>
        <c:noMultiLvlLbl val="0"/>
      </c:catAx>
      <c:valAx>
        <c:axId val="556170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fr-FR"/>
          </a:p>
        </c:txPr>
        <c:crossAx val="556154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0600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0334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3712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933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662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6454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0069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5153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8702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4971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156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BACDE2-72B0-4D86-A009-93E9EE8CA9FC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34E85-B5F3-40A2-8042-FF8DED331D6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3328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jpeg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9" name="ZoneTexte 1"/>
          <p:cNvSpPr txBox="1">
            <a:spLocks noChangeArrowheads="1"/>
          </p:cNvSpPr>
          <p:nvPr/>
        </p:nvSpPr>
        <p:spPr bwMode="auto">
          <a:xfrm>
            <a:off x="8427853" y="6328023"/>
            <a:ext cx="88777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: Signal activity in control experiments</a:t>
            </a:r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fr-F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3490552" y="333381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3994981" y="3333810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>
                <a:latin typeface="Arial" pitchFamily="34" charset="0"/>
                <a:ea typeface="Arial Unicode MS" pitchFamily="34" charset="-128"/>
                <a:cs typeface="Arial" pitchFamily="34" charset="0"/>
              </a:rPr>
              <a:t>Strep</a:t>
            </a:r>
            <a:r>
              <a:rPr lang="fr-FR" sz="1200" dirty="0">
                <a:latin typeface="Arial" pitchFamily="34" charset="0"/>
                <a:ea typeface="Arial Unicode MS" pitchFamily="34" charset="-128"/>
                <a:cs typeface="Arial" pitchFamily="34" charset="0"/>
              </a:rPr>
              <a:t>-Tag</a:t>
            </a:r>
          </a:p>
        </p:txBody>
      </p:sp>
      <p:graphicFrame>
        <p:nvGraphicFramePr>
          <p:cNvPr id="29" name="Chart 1">
            <a:extLst>
              <a:ext uri="{FF2B5EF4-FFF2-40B4-BE49-F238E27FC236}">
                <a16:creationId xmlns:a16="http://schemas.microsoft.com/office/drawing/2014/main" id="{B422C360-9C5A-474A-A1DC-A61BA0FB520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351123" y="758931"/>
          <a:ext cx="2367518" cy="27581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4" name="Groupe 43"/>
          <p:cNvGrpSpPr/>
          <p:nvPr/>
        </p:nvGrpSpPr>
        <p:grpSpPr>
          <a:xfrm>
            <a:off x="6174601" y="3333810"/>
            <a:ext cx="1683354" cy="276999"/>
            <a:chOff x="2208716" y="5697474"/>
            <a:chExt cx="1683354" cy="276999"/>
          </a:xfrm>
        </p:grpSpPr>
        <p:sp>
          <p:nvSpPr>
            <p:cNvPr id="24" name="ZoneTexte 23"/>
            <p:cNvSpPr txBox="1"/>
            <p:nvPr/>
          </p:nvSpPr>
          <p:spPr>
            <a:xfrm>
              <a:off x="2208716" y="5697474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Arial" pitchFamily="34" charset="0"/>
                  <a:cs typeface="Arial" pitchFamily="34" charset="0"/>
                </a:rPr>
                <a:t>RPuL2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2671864" y="5697474"/>
              <a:ext cx="12202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Arial" pitchFamily="34" charset="0"/>
                  <a:cs typeface="Arial" pitchFamily="34" charset="0"/>
                </a:rPr>
                <a:t>       SMc02178</a:t>
              </a:r>
            </a:p>
          </p:txBody>
        </p:sp>
      </p:grpSp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7E162BF6-8127-4832-BABB-AAD7338F8CD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913384" y="737487"/>
          <a:ext cx="1921578" cy="26261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5" name="Groupe 54"/>
          <p:cNvGrpSpPr/>
          <p:nvPr/>
        </p:nvGrpSpPr>
        <p:grpSpPr>
          <a:xfrm>
            <a:off x="2696545" y="3633853"/>
            <a:ext cx="3803217" cy="2511086"/>
            <a:chOff x="3630737" y="196334"/>
            <a:chExt cx="4198083" cy="3308408"/>
          </a:xfrm>
        </p:grpSpPr>
        <p:graphicFrame>
          <p:nvGraphicFramePr>
            <p:cNvPr id="22" name="Chart 2">
              <a:extLst>
                <a:ext uri="{FF2B5EF4-FFF2-40B4-BE49-F238E27FC236}">
                  <a16:creationId xmlns:a16="http://schemas.microsoft.com/office/drawing/2014/main" id="{55A44A47-7A15-44E8-88A2-CF9DACEBC66A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3630737" y="196334"/>
            <a:ext cx="4086799" cy="3254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42" name="Groupe 41"/>
            <p:cNvGrpSpPr/>
            <p:nvPr/>
          </p:nvGrpSpPr>
          <p:grpSpPr>
            <a:xfrm>
              <a:off x="4510918" y="3132474"/>
              <a:ext cx="3317902" cy="372268"/>
              <a:chOff x="5161970" y="3836811"/>
              <a:chExt cx="3317902" cy="372268"/>
            </a:xfrm>
          </p:grpSpPr>
          <p:sp>
            <p:nvSpPr>
              <p:cNvPr id="32" name="ZoneTexte 31"/>
              <p:cNvSpPr txBox="1"/>
              <p:nvPr/>
            </p:nvSpPr>
            <p:spPr>
              <a:xfrm>
                <a:off x="5161970" y="3844126"/>
                <a:ext cx="364858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B </a:t>
                </a:r>
              </a:p>
            </p:txBody>
          </p:sp>
          <p:sp>
            <p:nvSpPr>
              <p:cNvPr id="33" name="ZoneTexte 32"/>
              <p:cNvSpPr txBox="1"/>
              <p:nvPr/>
            </p:nvSpPr>
            <p:spPr>
              <a:xfrm>
                <a:off x="5430450" y="3844126"/>
                <a:ext cx="439174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CE</a:t>
                </a:r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>
                <a:off x="5784610" y="3844126"/>
                <a:ext cx="308236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F</a:t>
                </a: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6033334" y="3844126"/>
                <a:ext cx="412632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 W</a:t>
                </a:r>
              </a:p>
            </p:txBody>
          </p:sp>
          <p:sp>
            <p:nvSpPr>
              <p:cNvPr id="36" name="ZoneTexte 35"/>
              <p:cNvSpPr txBox="1"/>
              <p:nvPr/>
            </p:nvSpPr>
            <p:spPr>
              <a:xfrm>
                <a:off x="6617889" y="3844126"/>
                <a:ext cx="506412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  E2</a:t>
                </a:r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>
                <a:off x="6334581" y="3844126"/>
                <a:ext cx="458637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 E1</a:t>
                </a: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>
                <a:off x="6886115" y="3844126"/>
                <a:ext cx="554187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   E3</a:t>
                </a:r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>
                <a:off x="7683585" y="3836811"/>
                <a:ext cx="410863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E5</a:t>
                </a:r>
              </a:p>
            </p:txBody>
          </p:sp>
          <p:sp>
            <p:nvSpPr>
              <p:cNvPr id="40" name="ZoneTexte 39"/>
              <p:cNvSpPr txBox="1"/>
              <p:nvPr/>
            </p:nvSpPr>
            <p:spPr>
              <a:xfrm>
                <a:off x="7188161" y="3844127"/>
                <a:ext cx="793060" cy="36495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   E4     </a:t>
                </a:r>
              </a:p>
            </p:txBody>
          </p:sp>
          <p:sp>
            <p:nvSpPr>
              <p:cNvPr id="41" name="ZoneTexte 40"/>
              <p:cNvSpPr txBox="1"/>
              <p:nvPr/>
            </p:nvSpPr>
            <p:spPr>
              <a:xfrm>
                <a:off x="8040875" y="3844127"/>
                <a:ext cx="438997" cy="3649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E6</a:t>
                </a:r>
              </a:p>
            </p:txBody>
          </p:sp>
        </p:grpSp>
      </p:grpSp>
      <p:grpSp>
        <p:nvGrpSpPr>
          <p:cNvPr id="53" name="Groupe 52"/>
          <p:cNvGrpSpPr/>
          <p:nvPr/>
        </p:nvGrpSpPr>
        <p:grpSpPr>
          <a:xfrm>
            <a:off x="4556253" y="4269745"/>
            <a:ext cx="3308162" cy="1181183"/>
            <a:chOff x="3878092" y="4840033"/>
            <a:chExt cx="3241964" cy="1607954"/>
          </a:xfrm>
        </p:grpSpPr>
        <p:pic>
          <p:nvPicPr>
            <p:cNvPr id="6156" name="Picture 1"/>
            <p:cNvPicPr>
              <a:picLocks noChangeAspect="1" noChangeArrowheads="1"/>
            </p:cNvPicPr>
            <p:nvPr/>
          </p:nvPicPr>
          <p:blipFill>
            <a:blip r:embed="rId5" cstate="print"/>
            <a:srcRect t="16317" r="8907"/>
            <a:stretch>
              <a:fillRect/>
            </a:stretch>
          </p:blipFill>
          <p:spPr bwMode="auto">
            <a:xfrm flipH="1">
              <a:off x="3887887" y="5101364"/>
              <a:ext cx="3205626" cy="13466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51" name="Groupe 50"/>
            <p:cNvGrpSpPr/>
            <p:nvPr/>
          </p:nvGrpSpPr>
          <p:grpSpPr>
            <a:xfrm>
              <a:off x="3878092" y="4840033"/>
              <a:ext cx="3241964" cy="377091"/>
              <a:chOff x="5011386" y="4378127"/>
              <a:chExt cx="3241964" cy="299942"/>
            </a:xfrm>
          </p:grpSpPr>
          <p:grpSp>
            <p:nvGrpSpPr>
              <p:cNvPr id="50" name="Groupe 49"/>
              <p:cNvGrpSpPr/>
              <p:nvPr/>
            </p:nvGrpSpPr>
            <p:grpSpPr>
              <a:xfrm>
                <a:off x="5011386" y="4378127"/>
                <a:ext cx="1290508" cy="299942"/>
                <a:chOff x="5011386" y="4330627"/>
                <a:chExt cx="1290508" cy="299942"/>
              </a:xfrm>
            </p:grpSpPr>
            <p:sp>
              <p:nvSpPr>
                <p:cNvPr id="45" name="ZoneTexte 44"/>
                <p:cNvSpPr txBox="1"/>
                <p:nvPr/>
              </p:nvSpPr>
              <p:spPr>
                <a:xfrm>
                  <a:off x="5011386" y="4330627"/>
                  <a:ext cx="397866" cy="29993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Arial" pitchFamily="34" charset="0"/>
                      <a:cs typeface="Arial" pitchFamily="34" charset="0"/>
                    </a:rPr>
                    <a:t>CE</a:t>
                  </a:r>
                </a:p>
              </p:txBody>
            </p:sp>
            <p:sp>
              <p:nvSpPr>
                <p:cNvPr id="46" name="ZoneTexte 45"/>
                <p:cNvSpPr txBox="1"/>
                <p:nvPr/>
              </p:nvSpPr>
              <p:spPr>
                <a:xfrm>
                  <a:off x="5640778" y="4330628"/>
                  <a:ext cx="373820" cy="28327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100" dirty="0">
                      <a:latin typeface="Arial" pitchFamily="34" charset="0"/>
                      <a:cs typeface="Arial" pitchFamily="34" charset="0"/>
                    </a:rPr>
                    <a:t>F</a:t>
                  </a:r>
                </a:p>
              </p:txBody>
            </p:sp>
            <p:sp>
              <p:nvSpPr>
                <p:cNvPr id="47" name="ZoneTexte 46"/>
                <p:cNvSpPr txBox="1"/>
                <p:nvPr/>
              </p:nvSpPr>
              <p:spPr>
                <a:xfrm>
                  <a:off x="5854527" y="4330635"/>
                  <a:ext cx="447367" cy="299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Arial" pitchFamily="34" charset="0"/>
                      <a:cs typeface="Arial" pitchFamily="34" charset="0"/>
                    </a:rPr>
                    <a:t> W</a:t>
                  </a:r>
                </a:p>
              </p:txBody>
            </p:sp>
            <p:sp>
              <p:nvSpPr>
                <p:cNvPr id="48" name="ZoneTexte 47"/>
                <p:cNvSpPr txBox="1"/>
                <p:nvPr/>
              </p:nvSpPr>
              <p:spPr>
                <a:xfrm>
                  <a:off x="5284518" y="4330628"/>
                  <a:ext cx="458780" cy="2999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>
                      <a:latin typeface="Arial" pitchFamily="34" charset="0"/>
                      <a:cs typeface="Arial" pitchFamily="34" charset="0"/>
                    </a:rPr>
                    <a:t>MW</a:t>
                  </a:r>
                </a:p>
              </p:txBody>
            </p:sp>
          </p:grpSp>
          <p:sp>
            <p:nvSpPr>
              <p:cNvPr id="49" name="TextBox 6">
                <a:extLst/>
              </p:cNvPr>
              <p:cNvSpPr txBox="1"/>
              <p:nvPr/>
            </p:nvSpPr>
            <p:spPr bwMode="auto">
              <a:xfrm>
                <a:off x="6255886" y="4428430"/>
                <a:ext cx="1997464" cy="199956"/>
              </a:xfrm>
              <a:prstGeom prst="rect">
                <a:avLst/>
              </a:prstGeom>
              <a:noFill/>
            </p:spPr>
            <p:txBody>
              <a:bodyPr wrap="square" lIns="0" tIns="0" rIns="0" bIns="0">
                <a:spAutoFit/>
              </a:bodyPr>
              <a:lstStyle/>
              <a:p>
                <a:pPr>
                  <a:defRPr/>
                </a:pPr>
                <a:r>
                  <a:rPr lang="fr-FR" sz="1200" dirty="0">
                    <a:latin typeface="Arial" pitchFamily="34" charset="0"/>
                    <a:cs typeface="Arial" pitchFamily="34" charset="0"/>
                  </a:rPr>
                  <a:t>E1   E2   E3   E4   E5    E6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58" name="ZoneTexte 57"/>
          <p:cNvSpPr txBox="1"/>
          <p:nvPr/>
        </p:nvSpPr>
        <p:spPr>
          <a:xfrm>
            <a:off x="5184278" y="4262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153" name="TextBox 25"/>
          <p:cNvSpPr txBox="1">
            <a:spLocks noChangeArrowheads="1"/>
          </p:cNvSpPr>
          <p:nvPr/>
        </p:nvSpPr>
        <p:spPr bwMode="auto">
          <a:xfrm>
            <a:off x="2665045" y="3495640"/>
            <a:ext cx="28098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fr-F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51" name="TextBox 19"/>
          <p:cNvSpPr txBox="1">
            <a:spLocks noChangeArrowheads="1"/>
          </p:cNvSpPr>
          <p:nvPr/>
        </p:nvSpPr>
        <p:spPr bwMode="auto">
          <a:xfrm>
            <a:off x="2665045" y="426242"/>
            <a:ext cx="28098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fr-F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 rot="16200000">
            <a:off x="2348917" y="4256610"/>
            <a:ext cx="9172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unit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 rot="16200000">
            <a:off x="2199793" y="1606666"/>
            <a:ext cx="12154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unit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 rot="16200000">
            <a:off x="4394547" y="1915301"/>
            <a:ext cx="1832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units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/µg of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protein</a:t>
            </a:r>
            <a:r>
              <a:rPr lang="fr-FR" sz="1200" dirty="0">
                <a:latin typeface="Arial" pitchFamily="34" charset="0"/>
                <a:cs typeface="Arial" pitchFamily="34" charset="0"/>
              </a:rPr>
              <a:t>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5908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Grand écran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 Unicode MS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batut</dc:creator>
  <cp:lastModifiedBy>jbatut</cp:lastModifiedBy>
  <cp:revision>1</cp:revision>
  <dcterms:created xsi:type="dcterms:W3CDTF">2020-02-27T11:33:43Z</dcterms:created>
  <dcterms:modified xsi:type="dcterms:W3CDTF">2020-02-27T11:34:05Z</dcterms:modified>
</cp:coreProperties>
</file>